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nt Thomas" initials="LT" lastIdx="12" clrIdx="0">
    <p:extLst>
      <p:ext uri="{19B8F6BF-5375-455C-9EA6-DF929625EA0E}">
        <p15:presenceInfo xmlns:p15="http://schemas.microsoft.com/office/powerpoint/2012/main" userId="Laurent Thomas" providerId="None"/>
      </p:ext>
    </p:extLst>
  </p:cmAuthor>
  <p:cmAuthor id="2" name="Jochen Gehrig" initials="JG" lastIdx="1" clrIdx="1">
    <p:extLst>
      <p:ext uri="{19B8F6BF-5375-455C-9EA6-DF929625EA0E}">
        <p15:presenceInfo xmlns:p15="http://schemas.microsoft.com/office/powerpoint/2012/main" userId="e17c5368b07af81f" providerId="Windows Live"/>
      </p:ext>
    </p:extLst>
  </p:cmAuthor>
  <p:cmAuthor id="3" name="Laurent Thomas" initials="LT [2]" lastIdx="1" clrIdx="2">
    <p:extLst>
      <p:ext uri="{19B8F6BF-5375-455C-9EA6-DF929625EA0E}">
        <p15:presenceInfo xmlns:p15="http://schemas.microsoft.com/office/powerpoint/2012/main" userId="432562282df067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0A42D8-2BFE-4E61-8267-051B5D9CC847}" v="176" dt="2019-07-16T13:42:53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65" autoAdjust="0"/>
    <p:restoredTop sz="96437" autoAdjust="0"/>
  </p:normalViewPr>
  <p:slideViewPr>
    <p:cSldViewPr snapToGrid="0">
      <p:cViewPr varScale="1">
        <p:scale>
          <a:sx n="86" d="100"/>
          <a:sy n="86" d="100"/>
        </p:scale>
        <p:origin x="3624" y="65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t Thomas" userId="d07c2afa-7600-4104-9c40-efdb3c9bb3fe" providerId="ADAL" clId="{3195338E-1967-43C1-B6F5-662CE6F1D5F2}"/>
    <pc:docChg chg="undo redo custSel modSld">
      <pc:chgData name="Laurent Thomas" userId="d07c2afa-7600-4104-9c40-efdb3c9bb3fe" providerId="ADAL" clId="{3195338E-1967-43C1-B6F5-662CE6F1D5F2}" dt="2019-04-18T14:45:10.664" v="1192" actId="5793"/>
      <pc:docMkLst>
        <pc:docMk/>
      </pc:docMkLst>
      <pc:sldChg chg="modSp">
        <pc:chgData name="Laurent Thomas" userId="d07c2afa-7600-4104-9c40-efdb3c9bb3fe" providerId="ADAL" clId="{3195338E-1967-43C1-B6F5-662CE6F1D5F2}" dt="2019-04-18T12:49:06.532" v="739" actId="6549"/>
        <pc:sldMkLst>
          <pc:docMk/>
          <pc:sldMk cId="4178917446" sldId="256"/>
        </pc:sldMkLst>
        <pc:spChg chg="mod">
          <ac:chgData name="Laurent Thomas" userId="d07c2afa-7600-4104-9c40-efdb3c9bb3fe" providerId="ADAL" clId="{3195338E-1967-43C1-B6F5-662CE6F1D5F2}" dt="2019-04-18T12:49:06.532" v="739" actId="6549"/>
          <ac:spMkLst>
            <pc:docMk/>
            <pc:sldMk cId="4178917446" sldId="256"/>
            <ac:spMk id="149" creationId="{E1A19189-6B43-4B56-9A2A-02B9C2D36D15}"/>
          </ac:spMkLst>
        </pc:spChg>
      </pc:sldChg>
      <pc:sldChg chg="modSp addCm modCm">
        <pc:chgData name="Laurent Thomas" userId="d07c2afa-7600-4104-9c40-efdb3c9bb3fe" providerId="ADAL" clId="{3195338E-1967-43C1-B6F5-662CE6F1D5F2}" dt="2019-04-18T14:35:19.066" v="990" actId="1076"/>
        <pc:sldMkLst>
          <pc:docMk/>
          <pc:sldMk cId="41563390" sldId="257"/>
        </pc:sldMkLst>
        <pc:spChg chg="mod">
          <ac:chgData name="Laurent Thomas" userId="d07c2afa-7600-4104-9c40-efdb3c9bb3fe" providerId="ADAL" clId="{3195338E-1967-43C1-B6F5-662CE6F1D5F2}" dt="2019-04-18T14:35:19.066" v="990" actId="1076"/>
          <ac:spMkLst>
            <pc:docMk/>
            <pc:sldMk cId="41563390" sldId="257"/>
            <ac:spMk id="3" creationId="{39652878-DD47-47EA-A94F-0BE777ED1A12}"/>
          </ac:spMkLst>
        </pc:spChg>
        <pc:spChg chg="mod">
          <ac:chgData name="Laurent Thomas" userId="d07c2afa-7600-4104-9c40-efdb3c9bb3fe" providerId="ADAL" clId="{3195338E-1967-43C1-B6F5-662CE6F1D5F2}" dt="2019-04-18T14:35:02.431" v="966" actId="20577"/>
          <ac:spMkLst>
            <pc:docMk/>
            <pc:sldMk cId="41563390" sldId="257"/>
            <ac:spMk id="71" creationId="{4AFA6E16-1D37-4231-A1DD-D48CA4ED250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4" creationId="{FAFE6870-047A-4288-93AE-36E6864BFD8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7" creationId="{CB0B3EC6-2A12-4906-BF92-F3F681113874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0" creationId="{3A6811AE-4B92-4505-961A-1A7C44DA2E19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1" creationId="{F8AEB784-4F5E-4C78-B70D-3C896ADD2827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2" creationId="{E8F2D15D-D91F-4B14-8F7F-BB53DE91AE02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3" creationId="{0ED85B2A-6CE8-4D85-885E-2BB3C7798433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7" creationId="{FC85BC21-BC12-4472-94BC-A6B92E68E96D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8" creationId="{68077911-6985-437D-925B-A55EA0C4E00C}"/>
          </ac:spMkLst>
        </pc:spChg>
        <pc:grpChg chg="mod">
          <ac:chgData name="Laurent Thomas" userId="d07c2afa-7600-4104-9c40-efdb3c9bb3fe" providerId="ADAL" clId="{3195338E-1967-43C1-B6F5-662CE6F1D5F2}" dt="2019-04-18T14:34:11.738" v="952" actId="14826"/>
          <ac:grpSpMkLst>
            <pc:docMk/>
            <pc:sldMk cId="41563390" sldId="257"/>
            <ac:grpSpMk id="2" creationId="{EC24C004-F290-4A36-BB0B-7355B037A431}"/>
          </ac:grpSpMkLst>
        </pc:grpChg>
        <pc:picChg chg="mod modCrop">
          <ac:chgData name="Laurent Thomas" userId="d07c2afa-7600-4104-9c40-efdb3c9bb3fe" providerId="ADAL" clId="{3195338E-1967-43C1-B6F5-662CE6F1D5F2}" dt="2019-04-18T14:34:52.683" v="962" actId="1076"/>
          <ac:picMkLst>
            <pc:docMk/>
            <pc:sldMk cId="41563390" sldId="257"/>
            <ac:picMk id="66" creationId="{3A91618C-D872-4C52-8F44-343F20DE4B11}"/>
          </ac:picMkLst>
        </pc:picChg>
      </pc:sldChg>
      <pc:sldChg chg="modSp addCm delCm modCm">
        <pc:chgData name="Laurent Thomas" userId="d07c2afa-7600-4104-9c40-efdb3c9bb3fe" providerId="ADAL" clId="{3195338E-1967-43C1-B6F5-662CE6F1D5F2}" dt="2019-04-18T13:03:39.577" v="814" actId="1592"/>
        <pc:sldMkLst>
          <pc:docMk/>
          <pc:sldMk cId="954967040" sldId="258"/>
        </pc:sldMkLst>
        <pc:spChg chg="mod">
          <ac:chgData name="Laurent Thomas" userId="d07c2afa-7600-4104-9c40-efdb3c9bb3fe" providerId="ADAL" clId="{3195338E-1967-43C1-B6F5-662CE6F1D5F2}" dt="2019-04-18T13:02:30.325" v="812" actId="6549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 addCm delCm modCm">
        <pc:chgData name="Laurent Thomas" userId="d07c2afa-7600-4104-9c40-efdb3c9bb3fe" providerId="ADAL" clId="{3195338E-1967-43C1-B6F5-662CE6F1D5F2}" dt="2019-04-18T13:17:23.351" v="852" actId="1592"/>
        <pc:sldMkLst>
          <pc:docMk/>
          <pc:sldMk cId="2696059611" sldId="259"/>
        </pc:sldMkLst>
        <pc:spChg chg="del mod">
          <ac:chgData name="Laurent Thomas" userId="d07c2afa-7600-4104-9c40-efdb3c9bb3fe" providerId="ADAL" clId="{3195338E-1967-43C1-B6F5-662CE6F1D5F2}" dt="2019-04-17T13:55:33.732" v="304" actId="478"/>
          <ac:spMkLst>
            <pc:docMk/>
            <pc:sldMk cId="2696059611" sldId="259"/>
            <ac:spMk id="3" creationId="{DE20DD88-F891-43FC-915B-0E63E22AA3B7}"/>
          </ac:spMkLst>
        </pc:spChg>
        <pc:spChg chg="add del mod">
          <ac:chgData name="Laurent Thomas" userId="d07c2afa-7600-4104-9c40-efdb3c9bb3fe" providerId="ADAL" clId="{3195338E-1967-43C1-B6F5-662CE6F1D5F2}" dt="2019-04-17T13:55:32.024" v="303" actId="478"/>
          <ac:spMkLst>
            <pc:docMk/>
            <pc:sldMk cId="2696059611" sldId="259"/>
            <ac:spMk id="5" creationId="{BCE8E9BE-3C90-4A5D-9035-2A6DCD0C4220}"/>
          </ac:spMkLst>
        </pc:spChg>
        <pc:spChg chg="del mod">
          <ac:chgData name="Laurent Thomas" userId="d07c2afa-7600-4104-9c40-efdb3c9bb3fe" providerId="ADAL" clId="{3195338E-1967-43C1-B6F5-662CE6F1D5F2}" dt="2019-04-17T13:55:30.474" v="302" actId="478"/>
          <ac:spMkLst>
            <pc:docMk/>
            <pc:sldMk cId="2696059611" sldId="259"/>
            <ac:spMk id="14" creationId="{49E13396-EE7B-49FD-BD99-90A5AFFCA8BE}"/>
          </ac:spMkLst>
        </pc:spChg>
        <pc:spChg chg="mod">
          <ac:chgData name="Laurent Thomas" userId="d07c2afa-7600-4104-9c40-efdb3c9bb3fe" providerId="ADAL" clId="{3195338E-1967-43C1-B6F5-662CE6F1D5F2}" dt="2019-04-18T13:17:03.453" v="851" actId="207"/>
          <ac:spMkLst>
            <pc:docMk/>
            <pc:sldMk cId="2696059611" sldId="259"/>
            <ac:spMk id="15" creationId="{FBDB49C3-3B43-4D2C-B6F4-5936E707F25A}"/>
          </ac:spMkLst>
        </pc:spChg>
        <pc:spChg chg="add mod">
          <ac:chgData name="Laurent Thomas" userId="d07c2afa-7600-4104-9c40-efdb3c9bb3fe" providerId="ADAL" clId="{3195338E-1967-43C1-B6F5-662CE6F1D5F2}" dt="2019-04-17T13:56:25.335" v="348" actId="1076"/>
          <ac:spMkLst>
            <pc:docMk/>
            <pc:sldMk cId="2696059611" sldId="259"/>
            <ac:spMk id="19" creationId="{26B92ADD-264C-435C-A691-2C63721F4A59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0" creationId="{0B1E9D51-A775-4D81-9AD2-0DA677AB93A2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1" creationId="{B1059068-DA74-452B-8916-36890AE75231}"/>
          </ac:spMkLst>
        </pc:spChg>
        <pc:graphicFrameChg chg="mod">
          <ac:chgData name="Laurent Thomas" userId="d07c2afa-7600-4104-9c40-efdb3c9bb3fe" providerId="ADAL" clId="{3195338E-1967-43C1-B6F5-662CE6F1D5F2}" dt="2019-04-17T11:52:24.324" v="241"/>
          <ac:graphicFrameMkLst>
            <pc:docMk/>
            <pc:sldMk cId="2696059611" sldId="259"/>
            <ac:graphicFrameMk id="16" creationId="{66C7AC95-076C-4887-801F-7228D11BFB7C}"/>
          </ac:graphicFrameMkLst>
        </pc:graphicFrameChg>
        <pc:graphicFrameChg chg="mod">
          <ac:chgData name="Laurent Thomas" userId="d07c2afa-7600-4104-9c40-efdb3c9bb3fe" providerId="ADAL" clId="{3195338E-1967-43C1-B6F5-662CE6F1D5F2}" dt="2019-04-17T11:52:28.759" v="242"/>
          <ac:graphicFrameMkLst>
            <pc:docMk/>
            <pc:sldMk cId="2696059611" sldId="259"/>
            <ac:graphicFrameMk id="17" creationId="{311A2D58-DC55-477A-9E4B-32B32AFF3701}"/>
          </ac:graphicFrameMkLst>
        </pc:graphicFrameChg>
        <pc:picChg chg="add mod">
          <ac:chgData name="Laurent Thomas" userId="d07c2afa-7600-4104-9c40-efdb3c9bb3fe" providerId="ADAL" clId="{3195338E-1967-43C1-B6F5-662CE6F1D5F2}" dt="2019-04-17T13:56:28.170" v="349" actId="1076"/>
          <ac:picMkLst>
            <pc:docMk/>
            <pc:sldMk cId="2696059611" sldId="259"/>
            <ac:picMk id="18" creationId="{A433050D-5009-486D-AF69-CD9DF47B7433}"/>
          </ac:picMkLst>
        </pc:picChg>
      </pc:sldChg>
      <pc:sldChg chg="addSp delSp modSp mod">
        <pc:chgData name="Laurent Thomas" userId="d07c2afa-7600-4104-9c40-efdb3c9bb3fe" providerId="ADAL" clId="{3195338E-1967-43C1-B6F5-662CE6F1D5F2}" dt="2019-04-18T13:20:24.319" v="929" actId="20577"/>
        <pc:sldMkLst>
          <pc:docMk/>
          <pc:sldMk cId="2041531473" sldId="260"/>
        </pc:sldMkLst>
        <pc:spChg chg="mod">
          <ac:chgData name="Laurent Thomas" userId="d07c2afa-7600-4104-9c40-efdb3c9bb3fe" providerId="ADAL" clId="{3195338E-1967-43C1-B6F5-662CE6F1D5F2}" dt="2019-04-18T13:20:24.319" v="929" actId="20577"/>
          <ac:spMkLst>
            <pc:docMk/>
            <pc:sldMk cId="2041531473" sldId="260"/>
            <ac:spMk id="16" creationId="{31580A4B-710C-4333-88D7-A118688CF8C0}"/>
          </ac:spMkLst>
        </pc:spChg>
        <pc:spChg chg="del">
          <ac:chgData name="Laurent Thomas" userId="d07c2afa-7600-4104-9c40-efdb3c9bb3fe" providerId="ADAL" clId="{3195338E-1967-43C1-B6F5-662CE6F1D5F2}" dt="2019-04-17T11:59:04.945" v="249" actId="478"/>
          <ac:spMkLst>
            <pc:docMk/>
            <pc:sldMk cId="2041531473" sldId="260"/>
            <ac:spMk id="20" creationId="{9C778788-626C-4782-BB73-3F46E8D650E7}"/>
          </ac:spMkLst>
        </pc:spChg>
        <pc:spChg chg="del mod">
          <ac:chgData name="Laurent Thomas" userId="d07c2afa-7600-4104-9c40-efdb3c9bb3fe" providerId="ADAL" clId="{3195338E-1967-43C1-B6F5-662CE6F1D5F2}" dt="2019-04-17T12:16:49.735" v="269" actId="478"/>
          <ac:spMkLst>
            <pc:docMk/>
            <pc:sldMk cId="2041531473" sldId="260"/>
            <ac:spMk id="21" creationId="{B61AD068-BC9B-4D5C-8747-78AE01AB446E}"/>
          </ac:spMkLst>
        </pc:spChg>
        <pc:spChg chg="add del">
          <ac:chgData name="Laurent Thomas" userId="d07c2afa-7600-4104-9c40-efdb3c9bb3fe" providerId="ADAL" clId="{3195338E-1967-43C1-B6F5-662CE6F1D5F2}" dt="2019-04-17T11:59:19.527" v="252" actId="478"/>
          <ac:spMkLst>
            <pc:docMk/>
            <pc:sldMk cId="2041531473" sldId="260"/>
            <ac:spMk id="22" creationId="{DAF8B2B9-ACBE-4E17-92D5-735157B42D42}"/>
          </ac:spMkLst>
        </pc:spChg>
        <pc:spChg chg="del mod">
          <ac:chgData name="Laurent Thomas" userId="d07c2afa-7600-4104-9c40-efdb3c9bb3fe" providerId="ADAL" clId="{3195338E-1967-43C1-B6F5-662CE6F1D5F2}" dt="2019-04-17T13:56:38.810" v="350" actId="478"/>
          <ac:spMkLst>
            <pc:docMk/>
            <pc:sldMk cId="2041531473" sldId="260"/>
            <ac:spMk id="23" creationId="{06811210-B2F8-4822-AB79-F3682C7DE117}"/>
          </ac:spMkLst>
        </pc:spChg>
        <pc:spChg chg="del topLvl">
          <ac:chgData name="Laurent Thomas" userId="d07c2afa-7600-4104-9c40-efdb3c9bb3fe" providerId="ADAL" clId="{3195338E-1967-43C1-B6F5-662CE6F1D5F2}" dt="2019-04-17T12:00:02.243" v="256" actId="478"/>
          <ac:spMkLst>
            <pc:docMk/>
            <pc:sldMk cId="2041531473" sldId="260"/>
            <ac:spMk id="26" creationId="{DAAD124C-3075-4820-9384-3E40F6B88EEC}"/>
          </ac:spMkLst>
        </pc:spChg>
        <pc:spChg chg="mod">
          <ac:chgData name="Laurent Thomas" userId="d07c2afa-7600-4104-9c40-efdb3c9bb3fe" providerId="ADAL" clId="{3195338E-1967-43C1-B6F5-662CE6F1D5F2}" dt="2019-04-17T13:56:47.296" v="351" actId="208"/>
          <ac:spMkLst>
            <pc:docMk/>
            <pc:sldMk cId="2041531473" sldId="260"/>
            <ac:spMk id="35" creationId="{44AD0391-5766-44A3-9FCF-2BD372CEEFC0}"/>
          </ac:spMkLst>
        </pc:spChg>
        <pc:grpChg chg="add del">
          <ac:chgData name="Laurent Thomas" userId="d07c2afa-7600-4104-9c40-efdb3c9bb3fe" providerId="ADAL" clId="{3195338E-1967-43C1-B6F5-662CE6F1D5F2}" dt="2019-04-17T12:00:02.243" v="256" actId="478"/>
          <ac:grpSpMkLst>
            <pc:docMk/>
            <pc:sldMk cId="2041531473" sldId="260"/>
            <ac:grpSpMk id="24" creationId="{25F500B8-DB4E-4242-B946-6F3C8D1BB350}"/>
          </ac:grpSpMkLst>
        </pc:grpChg>
        <pc:grpChg chg="del">
          <ac:chgData name="Laurent Thomas" userId="d07c2afa-7600-4104-9c40-efdb3c9bb3fe" providerId="ADAL" clId="{3195338E-1967-43C1-B6F5-662CE6F1D5F2}" dt="2019-04-17T11:59:58.987" v="255" actId="478"/>
          <ac:grpSpMkLst>
            <pc:docMk/>
            <pc:sldMk cId="2041531473" sldId="260"/>
            <ac:grpSpMk id="25" creationId="{95E73464-9FAE-49B3-9EC1-01024CA8300D}"/>
          </ac:grpSpMkLst>
        </pc:grpChg>
        <pc:grpChg chg="del">
          <ac:chgData name="Laurent Thomas" userId="d07c2afa-7600-4104-9c40-efdb3c9bb3fe" providerId="ADAL" clId="{3195338E-1967-43C1-B6F5-662CE6F1D5F2}" dt="2019-04-17T12:00:16.776" v="259" actId="478"/>
          <ac:grpSpMkLst>
            <pc:docMk/>
            <pc:sldMk cId="2041531473" sldId="260"/>
            <ac:grpSpMk id="27" creationId="{B7BDDF78-1A41-4BF7-86FA-F45A2E1D9DD4}"/>
          </ac:grpSpMkLst>
        </pc:grpChg>
        <pc:grpChg chg="mod topLvl">
          <ac:chgData name="Laurent Thomas" userId="d07c2afa-7600-4104-9c40-efdb3c9bb3fe" providerId="ADAL" clId="{3195338E-1967-43C1-B6F5-662CE6F1D5F2}" dt="2019-04-17T12:00:26.376" v="262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3195338E-1967-43C1-B6F5-662CE6F1D5F2}" dt="2019-04-17T12:49:54.034" v="281" actId="1076"/>
          <ac:graphicFrameMkLst>
            <pc:docMk/>
            <pc:sldMk cId="2041531473" sldId="260"/>
            <ac:graphicFrameMk id="19" creationId="{BF9C97E2-F78F-48D5-A595-77AF24CE1E54}"/>
          </ac:graphicFrameMkLst>
        </pc:graphicFrameChg>
        <pc:picChg chg="mod">
          <ac:chgData name="Laurent Thomas" userId="d07c2afa-7600-4104-9c40-efdb3c9bb3fe" providerId="ADAL" clId="{3195338E-1967-43C1-B6F5-662CE6F1D5F2}" dt="2019-04-17T12:16:44.357" v="268" actId="14826"/>
          <ac:picMkLst>
            <pc:docMk/>
            <pc:sldMk cId="2041531473" sldId="260"/>
            <ac:picMk id="4" creationId="{D1FB124E-7E7E-4E66-97DD-05B5B27523ED}"/>
          </ac:picMkLst>
        </pc:picChg>
        <pc:picChg chg="del">
          <ac:chgData name="Laurent Thomas" userId="d07c2afa-7600-4104-9c40-efdb3c9bb3fe" providerId="ADAL" clId="{3195338E-1967-43C1-B6F5-662CE6F1D5F2}" dt="2019-04-17T11:59:58.987" v="255" actId="478"/>
          <ac:picMkLst>
            <pc:docMk/>
            <pc:sldMk cId="2041531473" sldId="260"/>
            <ac:picMk id="31" creationId="{E464253D-7F2A-42EA-8FBA-22ED5D6CC288}"/>
          </ac:picMkLst>
        </pc:picChg>
      </pc:sldChg>
      <pc:sldChg chg="delSp modSp addCm delCm modCm">
        <pc:chgData name="Laurent Thomas" userId="d07c2afa-7600-4104-9c40-efdb3c9bb3fe" providerId="ADAL" clId="{3195338E-1967-43C1-B6F5-662CE6F1D5F2}" dt="2019-04-18T13:12:35.296" v="818" actId="1592"/>
        <pc:sldMkLst>
          <pc:docMk/>
          <pc:sldMk cId="3177686218" sldId="263"/>
        </pc:sldMkLst>
        <pc:spChg chg="mod">
          <ac:chgData name="Laurent Thomas" userId="d07c2afa-7600-4104-9c40-efdb3c9bb3fe" providerId="ADAL" clId="{3195338E-1967-43C1-B6F5-662CE6F1D5F2}" dt="2019-04-18T13:04:20.823" v="815" actId="113"/>
          <ac:spMkLst>
            <pc:docMk/>
            <pc:sldMk cId="3177686218" sldId="263"/>
            <ac:spMk id="2" creationId="{D7AD1382-C71C-414F-90C8-F6EB53D3F368}"/>
          </ac:spMkLst>
        </pc:spChg>
        <pc:spChg chg="del">
          <ac:chgData name="Laurent Thomas" userId="d07c2afa-7600-4104-9c40-efdb3c9bb3fe" providerId="ADAL" clId="{3195338E-1967-43C1-B6F5-662CE6F1D5F2}" dt="2019-04-17T12:05:53.615" v="263" actId="478"/>
          <ac:spMkLst>
            <pc:docMk/>
            <pc:sldMk cId="3177686218" sldId="263"/>
            <ac:spMk id="3" creationId="{469E8CBC-E8DA-4BCC-8CAD-DC5E563ED8AA}"/>
          </ac:spMkLst>
        </pc:spChg>
        <pc:picChg chg="mod">
          <ac:chgData name="Laurent Thomas" userId="d07c2afa-7600-4104-9c40-efdb3c9bb3fe" providerId="ADAL" clId="{3195338E-1967-43C1-B6F5-662CE6F1D5F2}" dt="2019-04-17T12:06:08.480" v="264" actId="14826"/>
          <ac:picMkLst>
            <pc:docMk/>
            <pc:sldMk cId="3177686218" sldId="263"/>
            <ac:picMk id="30" creationId="{79329347-DB05-43BD-A2A7-E52E9F5C95C3}"/>
          </ac:picMkLst>
        </pc:picChg>
      </pc:sldChg>
      <pc:sldChg chg="delSp modSp mod">
        <pc:chgData name="Laurent Thomas" userId="d07c2afa-7600-4104-9c40-efdb3c9bb3fe" providerId="ADAL" clId="{3195338E-1967-43C1-B6F5-662CE6F1D5F2}" dt="2019-04-18T14:45:10.664" v="1192" actId="5793"/>
        <pc:sldMkLst>
          <pc:docMk/>
          <pc:sldMk cId="1422248035" sldId="264"/>
        </pc:sldMkLst>
        <pc:spChg chg="del">
          <ac:chgData name="Laurent Thomas" userId="d07c2afa-7600-4104-9c40-efdb3c9bb3fe" providerId="ADAL" clId="{3195338E-1967-43C1-B6F5-662CE6F1D5F2}" dt="2019-04-17T13:56:54.680" v="352" actId="478"/>
          <ac:spMkLst>
            <pc:docMk/>
            <pc:sldMk cId="1422248035" sldId="264"/>
            <ac:spMk id="2" creationId="{02DED4FE-179F-4634-82A8-9B81857AE277}"/>
          </ac:spMkLst>
        </pc:spChg>
        <pc:spChg chg="mod">
          <ac:chgData name="Laurent Thomas" userId="d07c2afa-7600-4104-9c40-efdb3c9bb3fe" providerId="ADAL" clId="{3195338E-1967-43C1-B6F5-662CE6F1D5F2}" dt="2019-04-18T14:45:10.664" v="1192" actId="5793"/>
          <ac:spMkLst>
            <pc:docMk/>
            <pc:sldMk cId="1422248035" sldId="264"/>
            <ac:spMk id="6" creationId="{57B60F66-23E1-4EFD-BD1F-97B008226761}"/>
          </ac:spMkLst>
        </pc:spChg>
        <pc:spChg chg="del mod">
          <ac:chgData name="Laurent Thomas" userId="d07c2afa-7600-4104-9c40-efdb3c9bb3fe" providerId="ADAL" clId="{3195338E-1967-43C1-B6F5-662CE6F1D5F2}" dt="2019-04-18T14:42:12.674" v="993" actId="478"/>
          <ac:spMkLst>
            <pc:docMk/>
            <pc:sldMk cId="1422248035" sldId="264"/>
            <ac:spMk id="14" creationId="{8D1724AB-7BF4-4A0E-A7D9-DC62D3506298}"/>
          </ac:spMkLst>
        </pc:spChg>
        <pc:graphicFrameChg chg="mod">
          <ac:chgData name="Laurent Thomas" userId="d07c2afa-7600-4104-9c40-efdb3c9bb3fe" providerId="ADAL" clId="{3195338E-1967-43C1-B6F5-662CE6F1D5F2}" dt="2019-04-18T14:32:47.097" v="949"/>
          <ac:graphicFrameMkLst>
            <pc:docMk/>
            <pc:sldMk cId="1422248035" sldId="264"/>
            <ac:graphicFrameMk id="12" creationId="{58447200-9E6E-46C5-B90D-EEA64C0F3B76}"/>
          </ac:graphicFrameMkLst>
        </pc:graphicFrameChg>
        <pc:graphicFrameChg chg="mod">
          <ac:chgData name="Laurent Thomas" userId="d07c2afa-7600-4104-9c40-efdb3c9bb3fe" providerId="ADAL" clId="{3195338E-1967-43C1-B6F5-662CE6F1D5F2}" dt="2019-04-18T14:32:37.973" v="946"/>
          <ac:graphicFrameMkLst>
            <pc:docMk/>
            <pc:sldMk cId="1422248035" sldId="264"/>
            <ac:graphicFrameMk id="13" creationId="{D03F9B69-F1B7-4869-B01D-D09CE239C2E3}"/>
          </ac:graphicFrameMkLst>
        </pc:graphicFrameChg>
        <pc:picChg chg="mod modCrop">
          <ac:chgData name="Laurent Thomas" userId="d07c2afa-7600-4104-9c40-efdb3c9bb3fe" providerId="ADAL" clId="{3195338E-1967-43C1-B6F5-662CE6F1D5F2}" dt="2019-04-18T14:42:57.547" v="1001" actId="1076"/>
          <ac:picMkLst>
            <pc:docMk/>
            <pc:sldMk cId="1422248035" sldId="264"/>
            <ac:picMk id="4" creationId="{9578C9AB-E1C9-4DD6-A2C6-18D31509A353}"/>
          </ac:picMkLst>
        </pc:picChg>
      </pc:sldChg>
    </pc:docChg>
  </pc:docChgLst>
  <pc:docChgLst>
    <pc:chgData name="Laurent Thomas" userId="d07c2afa-7600-4104-9c40-efdb3c9bb3fe" providerId="ADAL" clId="{1A6F276E-1E6C-4FAB-8546-BBBDC97ADF81}"/>
  </pc:docChgLst>
  <pc:docChgLst>
    <pc:chgData name="Laurent Thomas" userId="d07c2afa-7600-4104-9c40-efdb3c9bb3fe" providerId="ADAL" clId="{31733BA4-818B-4EAF-A648-8AA7094CEAE3}"/>
  </pc:docChgLst>
  <pc:docChgLst>
    <pc:chgData name="Laurent Thomas" userId="d07c2afa-7600-4104-9c40-efdb3c9bb3fe" providerId="ADAL" clId="{490A42D8-2BFE-4E61-8267-051B5D9CC847}"/>
    <pc:docChg chg="undo custSel addSld delSld modSld sldOrd">
      <pc:chgData name="Laurent Thomas" userId="d07c2afa-7600-4104-9c40-efdb3c9bb3fe" providerId="ADAL" clId="{490A42D8-2BFE-4E61-8267-051B5D9CC847}" dt="2019-07-16T15:20:34.170" v="972" actId="20577"/>
      <pc:docMkLst>
        <pc:docMk/>
      </pc:docMkLst>
      <pc:sldChg chg="modSp">
        <pc:chgData name="Laurent Thomas" userId="d07c2afa-7600-4104-9c40-efdb3c9bb3fe" providerId="ADAL" clId="{490A42D8-2BFE-4E61-8267-051B5D9CC847}" dt="2019-07-08T14:29:13.407" v="779" actId="207"/>
        <pc:sldMkLst>
          <pc:docMk/>
          <pc:sldMk cId="41563390" sldId="257"/>
        </pc:sldMkLst>
        <pc:spChg chg="mod">
          <ac:chgData name="Laurent Thomas" userId="d07c2afa-7600-4104-9c40-efdb3c9bb3fe" providerId="ADAL" clId="{490A42D8-2BFE-4E61-8267-051B5D9CC847}" dt="2019-07-08T14:29:13.407" v="779" actId="207"/>
          <ac:spMkLst>
            <pc:docMk/>
            <pc:sldMk cId="41563390" sldId="257"/>
            <ac:spMk id="71" creationId="{4AFA6E16-1D37-4231-A1DD-D48CA4ED2506}"/>
          </ac:spMkLst>
        </pc:spChg>
      </pc:sldChg>
      <pc:sldChg chg="modSp addCm delCm modCm">
        <pc:chgData name="Laurent Thomas" userId="d07c2afa-7600-4104-9c40-efdb3c9bb3fe" providerId="ADAL" clId="{490A42D8-2BFE-4E61-8267-051B5D9CC847}" dt="2019-07-09T07:46:29.862" v="949" actId="1592"/>
        <pc:sldMkLst>
          <pc:docMk/>
          <pc:sldMk cId="954967040" sldId="258"/>
        </pc:sldMkLst>
        <pc:spChg chg="mod">
          <ac:chgData name="Laurent Thomas" userId="d07c2afa-7600-4104-9c40-efdb3c9bb3fe" providerId="ADAL" clId="{490A42D8-2BFE-4E61-8267-051B5D9CC847}" dt="2019-07-09T07:45:41.764" v="947" actId="20577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Transition">
        <pc:chgData name="Laurent Thomas" userId="d07c2afa-7600-4104-9c40-efdb3c9bb3fe" providerId="ADAL" clId="{490A42D8-2BFE-4E61-8267-051B5D9CC847}" dt="2019-07-16T13:42:53.085" v="954"/>
        <pc:sldMkLst>
          <pc:docMk/>
          <pc:sldMk cId="2696059611" sldId="259"/>
        </pc:sldMkLst>
        <pc:spChg chg="add del mod">
          <ac:chgData name="Laurent Thomas" userId="d07c2afa-7600-4104-9c40-efdb3c9bb3fe" providerId="ADAL" clId="{490A42D8-2BFE-4E61-8267-051B5D9CC847}" dt="2019-07-16T13:36:55.516" v="952" actId="478"/>
          <ac:spMkLst>
            <pc:docMk/>
            <pc:sldMk cId="2696059611" sldId="259"/>
            <ac:spMk id="3" creationId="{CA3536D2-E5F3-4667-8C1A-F8CFDA114ABD}"/>
          </ac:spMkLst>
        </pc:spChg>
      </pc:sldChg>
      <pc:sldChg chg="modSp">
        <pc:chgData name="Laurent Thomas" userId="d07c2afa-7600-4104-9c40-efdb3c9bb3fe" providerId="ADAL" clId="{490A42D8-2BFE-4E61-8267-051B5D9CC847}" dt="2019-07-09T07:47:20.195" v="950" actId="6549"/>
        <pc:sldMkLst>
          <pc:docMk/>
          <pc:sldMk cId="2041531473" sldId="260"/>
        </pc:sldMkLst>
        <pc:spChg chg="mod">
          <ac:chgData name="Laurent Thomas" userId="d07c2afa-7600-4104-9c40-efdb3c9bb3fe" providerId="ADAL" clId="{490A42D8-2BFE-4E61-8267-051B5D9CC847}" dt="2019-07-09T07:47:20.195" v="950" actId="6549"/>
          <ac:spMkLst>
            <pc:docMk/>
            <pc:sldMk cId="2041531473" sldId="260"/>
            <ac:spMk id="16" creationId="{31580A4B-710C-4333-88D7-A118688CF8C0}"/>
          </ac:spMkLst>
        </pc:spChg>
        <pc:grpChg chg="mod">
          <ac:chgData name="Laurent Thomas" userId="d07c2afa-7600-4104-9c40-efdb3c9bb3fe" providerId="ADAL" clId="{490A42D8-2BFE-4E61-8267-051B5D9CC847}" dt="2019-07-08T14:10:09.890" v="706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490A42D8-2BFE-4E61-8267-051B5D9CC847}" dt="2019-07-08T14:36:30.077" v="921" actId="20577"/>
          <ac:graphicFrameMkLst>
            <pc:docMk/>
            <pc:sldMk cId="2041531473" sldId="260"/>
            <ac:graphicFrameMk id="18" creationId="{46D5330F-2946-44D7-9EEB-10389468BBF3}"/>
          </ac:graphicFrameMkLst>
        </pc:graphicFrame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1" creationId="{2887985F-6EF1-4E14-B2FA-9AD217E69826}"/>
          </ac:picMkLst>
        </pc:pic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3" creationId="{7BA44751-C190-4A9F-A51F-DB0A10D3AED2}"/>
          </ac:picMkLst>
        </pc:picChg>
      </pc:sldChg>
      <pc:sldChg chg="modSp del">
        <pc:chgData name="Laurent Thomas" userId="d07c2afa-7600-4104-9c40-efdb3c9bb3fe" providerId="ADAL" clId="{490A42D8-2BFE-4E61-8267-051B5D9CC847}" dt="2019-07-16T14:23:17.427" v="959" actId="2696"/>
        <pc:sldMkLst>
          <pc:docMk/>
          <pc:sldMk cId="1817074957" sldId="261"/>
        </pc:sldMkLst>
        <pc:spChg chg="mod">
          <ac:chgData name="Laurent Thomas" userId="d07c2afa-7600-4104-9c40-efdb3c9bb3fe" providerId="ADAL" clId="{490A42D8-2BFE-4E61-8267-051B5D9CC847}" dt="2019-07-08T15:00:08.649" v="938" actId="20578"/>
          <ac:spMkLst>
            <pc:docMk/>
            <pc:sldMk cId="1817074957" sldId="261"/>
            <ac:spMk id="4" creationId="{5C8D6550-A82A-4F0A-A30F-E7ABE61D1E13}"/>
          </ac:spMkLst>
        </pc:spChg>
        <pc:grpChg chg="mod">
          <ac:chgData name="Laurent Thomas" userId="d07c2afa-7600-4104-9c40-efdb3c9bb3fe" providerId="ADAL" clId="{490A42D8-2BFE-4E61-8267-051B5D9CC847}" dt="2019-07-08T14:27:24.673" v="774" actId="1076"/>
          <ac:grpSpMkLst>
            <pc:docMk/>
            <pc:sldMk cId="1817074957" sldId="261"/>
            <ac:grpSpMk id="19" creationId="{A55D236E-1C03-4A29-B50F-0B0FE807CBB4}"/>
          </ac:grpSpMkLst>
        </pc:grpChg>
      </pc:sldChg>
      <pc:sldChg chg="modSp">
        <pc:chgData name="Laurent Thomas" userId="d07c2afa-7600-4104-9c40-efdb3c9bb3fe" providerId="ADAL" clId="{490A42D8-2BFE-4E61-8267-051B5D9CC847}" dt="2019-07-08T14:33:37.100" v="866" actId="20577"/>
        <pc:sldMkLst>
          <pc:docMk/>
          <pc:sldMk cId="3177686218" sldId="263"/>
        </pc:sldMkLst>
        <pc:spChg chg="mod">
          <ac:chgData name="Laurent Thomas" userId="d07c2afa-7600-4104-9c40-efdb3c9bb3fe" providerId="ADAL" clId="{490A42D8-2BFE-4E61-8267-051B5D9CC847}" dt="2019-07-08T14:33:37.100" v="866" actId="20577"/>
          <ac:spMkLst>
            <pc:docMk/>
            <pc:sldMk cId="3177686218" sldId="263"/>
            <ac:spMk id="2" creationId="{D7AD1382-C71C-414F-90C8-F6EB53D3F368}"/>
          </ac:spMkLst>
        </pc:spChg>
      </pc:sldChg>
      <pc:sldChg chg="modSp">
        <pc:chgData name="Laurent Thomas" userId="d07c2afa-7600-4104-9c40-efdb3c9bb3fe" providerId="ADAL" clId="{490A42D8-2BFE-4E61-8267-051B5D9CC847}" dt="2019-07-08T14:37:37.541" v="936" actId="20577"/>
        <pc:sldMkLst>
          <pc:docMk/>
          <pc:sldMk cId="1422248035" sldId="264"/>
        </pc:sldMkLst>
        <pc:spChg chg="mod">
          <ac:chgData name="Laurent Thomas" userId="d07c2afa-7600-4104-9c40-efdb3c9bb3fe" providerId="ADAL" clId="{490A42D8-2BFE-4E61-8267-051B5D9CC847}" dt="2019-07-08T14:37:37.541" v="936" actId="20577"/>
          <ac:spMkLst>
            <pc:docMk/>
            <pc:sldMk cId="1422248035" sldId="264"/>
            <ac:spMk id="6" creationId="{57B60F66-23E1-4EFD-BD1F-97B008226761}"/>
          </ac:spMkLst>
        </pc:spChg>
      </pc:sldChg>
      <pc:sldChg chg="addSp delSp modSp add mod ord">
        <pc:chgData name="Laurent Thomas" userId="d07c2afa-7600-4104-9c40-efdb3c9bb3fe" providerId="ADAL" clId="{490A42D8-2BFE-4E61-8267-051B5D9CC847}" dt="2019-07-16T15:20:34.170" v="972" actId="20577"/>
        <pc:sldMkLst>
          <pc:docMk/>
          <pc:sldMk cId="607201000" sldId="265"/>
        </pc:sldMkLst>
        <pc:spChg chg="mod topLvl">
          <ac:chgData name="Laurent Thomas" userId="d07c2afa-7600-4104-9c40-efdb3c9bb3fe" providerId="ADAL" clId="{490A42D8-2BFE-4E61-8267-051B5D9CC847}" dt="2019-06-19T09:13:20.071" v="570" actId="1076"/>
          <ac:spMkLst>
            <pc:docMk/>
            <pc:sldMk cId="607201000" sldId="265"/>
            <ac:spMk id="2" creationId="{99A1882E-6077-48B5-A5A4-E2D0E1B90D71}"/>
          </ac:spMkLst>
        </pc:spChg>
        <pc:spChg chg="mod">
          <ac:chgData name="Laurent Thomas" userId="d07c2afa-7600-4104-9c40-efdb3c9bb3fe" providerId="ADAL" clId="{490A42D8-2BFE-4E61-8267-051B5D9CC847}" dt="2019-07-16T15:20:34.170" v="972" actId="20577"/>
          <ac:spMkLst>
            <pc:docMk/>
            <pc:sldMk cId="607201000" sldId="265"/>
            <ac:spMk id="15" creationId="{FBDB49C3-3B43-4D2C-B6F4-5936E707F25A}"/>
          </ac:spMkLst>
        </pc:spChg>
        <pc:spChg chg="add mod">
          <ac:chgData name="Laurent Thomas" userId="d07c2afa-7600-4104-9c40-efdb3c9bb3fe" providerId="ADAL" clId="{490A42D8-2BFE-4E61-8267-051B5D9CC847}" dt="2019-06-19T09:12:55.432" v="567" actId="1076"/>
          <ac:spMkLst>
            <pc:docMk/>
            <pc:sldMk cId="607201000" sldId="265"/>
            <ac:spMk id="17" creationId="{57A3B65F-008D-4FFA-B3A6-430E929A0EB9}"/>
          </ac:spMkLst>
        </pc:spChg>
        <pc:spChg chg="add mod">
          <ac:chgData name="Laurent Thomas" userId="d07c2afa-7600-4104-9c40-efdb3c9bb3fe" providerId="ADAL" clId="{490A42D8-2BFE-4E61-8267-051B5D9CC847}" dt="2019-07-03T12:29:59.976" v="674" actId="1076"/>
          <ac:spMkLst>
            <pc:docMk/>
            <pc:sldMk cId="607201000" sldId="265"/>
            <ac:spMk id="18" creationId="{F7EACBD6-E691-4E6C-B90A-9B2F2D626F73}"/>
          </ac:spMkLst>
        </pc:spChg>
        <pc:spChg chg="del">
          <ac:chgData name="Laurent Thomas" userId="d07c2afa-7600-4104-9c40-efdb3c9bb3fe" providerId="ADAL" clId="{490A42D8-2BFE-4E61-8267-051B5D9CC847}" dt="2019-06-18T11:48:09.024" v="156" actId="478"/>
          <ac:spMkLst>
            <pc:docMk/>
            <pc:sldMk cId="607201000" sldId="265"/>
            <ac:spMk id="19" creationId="{26B92ADD-264C-435C-A691-2C63721F4A59}"/>
          </ac:spMkLst>
        </pc:spChg>
        <pc:spChg chg="add mod">
          <ac:chgData name="Laurent Thomas" userId="d07c2afa-7600-4104-9c40-efdb3c9bb3fe" providerId="ADAL" clId="{490A42D8-2BFE-4E61-8267-051B5D9CC847}" dt="2019-07-03T12:29:54.737" v="673" actId="1076"/>
          <ac:spMkLst>
            <pc:docMk/>
            <pc:sldMk cId="607201000" sldId="265"/>
            <ac:spMk id="19" creationId="{91C4126C-9D5B-45F7-83F2-31D2F66656D9}"/>
          </ac:spMkLst>
        </pc:spChg>
        <pc:spChg chg="mod">
          <ac:chgData name="Laurent Thomas" userId="d07c2afa-7600-4104-9c40-efdb3c9bb3fe" providerId="ADAL" clId="{490A42D8-2BFE-4E61-8267-051B5D9CC847}" dt="2019-06-19T09:08:19.319" v="445" actId="1076"/>
          <ac:spMkLst>
            <pc:docMk/>
            <pc:sldMk cId="607201000" sldId="265"/>
            <ac:spMk id="20" creationId="{0B1E9D51-A775-4D81-9AD2-0DA677AB93A2}"/>
          </ac:spMkLst>
        </pc:spChg>
        <pc:spChg chg="del">
          <ac:chgData name="Laurent Thomas" userId="d07c2afa-7600-4104-9c40-efdb3c9bb3fe" providerId="ADAL" clId="{490A42D8-2BFE-4E61-8267-051B5D9CC847}" dt="2019-06-18T11:48:18.770" v="159" actId="478"/>
          <ac:spMkLst>
            <pc:docMk/>
            <pc:sldMk cId="607201000" sldId="265"/>
            <ac:spMk id="21" creationId="{B1059068-DA74-452B-8916-36890AE75231}"/>
          </ac:spMkLst>
        </pc:spChg>
        <pc:spChg chg="add mod">
          <ac:chgData name="Laurent Thomas" userId="d07c2afa-7600-4104-9c40-efdb3c9bb3fe" providerId="ADAL" clId="{490A42D8-2BFE-4E61-8267-051B5D9CC847}" dt="2019-06-19T09:13:26.936" v="571" actId="1076"/>
          <ac:spMkLst>
            <pc:docMk/>
            <pc:sldMk cId="607201000" sldId="265"/>
            <ac:spMk id="24" creationId="{17D5F645-D02C-420F-BDB7-8D8BB6B2AA8E}"/>
          </ac:spMkLst>
        </pc:spChg>
        <pc:grpChg chg="add mod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3" creationId="{7F0B00AB-F70D-4B28-B761-65BA527CC726}"/>
          </ac:grpSpMkLst>
        </pc:grpChg>
        <pc:grpChg chg="mod topLvl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4" creationId="{E1901F4D-CDD8-4582-986D-D14B7B8ECB34}"/>
          </ac:grpSpMkLst>
        </pc:grpChg>
        <pc:grpChg chg="del mod">
          <ac:chgData name="Laurent Thomas" userId="d07c2afa-7600-4104-9c40-efdb3c9bb3fe" providerId="ADAL" clId="{490A42D8-2BFE-4E61-8267-051B5D9CC847}" dt="2019-06-19T09:04:42.314" v="421" actId="165"/>
          <ac:grpSpMkLst>
            <pc:docMk/>
            <pc:sldMk cId="607201000" sldId="265"/>
            <ac:grpSpMk id="5" creationId="{8C4C8FCE-31E4-455F-AE69-8995FF08EA7E}"/>
          </ac:grpSpMkLst>
        </pc:grpChg>
        <pc:grpChg chg="add mod">
          <ac:chgData name="Laurent Thomas" userId="d07c2afa-7600-4104-9c40-efdb3c9bb3fe" providerId="ADAL" clId="{490A42D8-2BFE-4E61-8267-051B5D9CC847}" dt="2019-07-03T12:29:44.961" v="671" actId="14100"/>
          <ac:grpSpMkLst>
            <pc:docMk/>
            <pc:sldMk cId="607201000" sldId="265"/>
            <ac:grpSpMk id="11" creationId="{C94E5479-BEF9-4434-AFD0-B9006E5871C9}"/>
          </ac:grpSpMkLst>
        </pc:grpChg>
        <pc:graphicFrameChg chg="del">
          <ac:chgData name="Laurent Thomas" userId="d07c2afa-7600-4104-9c40-efdb3c9bb3fe" providerId="ADAL" clId="{490A42D8-2BFE-4E61-8267-051B5D9CC847}" dt="2019-06-18T12:47:55.775" v="354" actId="478"/>
          <ac:graphicFrameMkLst>
            <pc:docMk/>
            <pc:sldMk cId="607201000" sldId="265"/>
            <ac:graphicFrameMk id="16" creationId="{66C7AC95-076C-4887-801F-7228D11BFB7C}"/>
          </ac:graphicFrameMkLst>
        </pc:graphicFrameChg>
        <pc:graphicFrameChg chg="del">
          <ac:chgData name="Laurent Thomas" userId="d07c2afa-7600-4104-9c40-efdb3c9bb3fe" providerId="ADAL" clId="{490A42D8-2BFE-4E61-8267-051B5D9CC847}" dt="2019-06-18T11:48:13.543" v="157" actId="478"/>
          <ac:graphicFrameMkLst>
            <pc:docMk/>
            <pc:sldMk cId="607201000" sldId="265"/>
            <ac:graphicFrameMk id="17" creationId="{311A2D58-DC55-477A-9E4B-32B32AFF3701}"/>
          </ac:graphicFrameMkLst>
        </pc:graphicFrameChg>
        <pc:graphicFrameChg chg="add del mod">
          <ac:chgData name="Laurent Thomas" userId="d07c2afa-7600-4104-9c40-efdb3c9bb3fe" providerId="ADAL" clId="{490A42D8-2BFE-4E61-8267-051B5D9CC847}" dt="2019-06-18T12:47:25.486" v="339" actId="478"/>
          <ac:graphicFrameMkLst>
            <pc:docMk/>
            <pc:sldMk cId="607201000" sldId="265"/>
            <ac:graphicFrameMk id="22" creationId="{91D2C72B-F872-488B-A255-EEFFF805B266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12:50.591" v="566" actId="1076"/>
          <ac:graphicFrameMkLst>
            <pc:docMk/>
            <pc:sldMk cId="607201000" sldId="265"/>
            <ac:graphicFrameMk id="23" creationId="{32C0F9A0-E1CC-4FC4-8E15-66C2CF753B01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08:15.272" v="444" actId="167"/>
          <ac:graphicFrameMkLst>
            <pc:docMk/>
            <pc:sldMk cId="607201000" sldId="265"/>
            <ac:graphicFrameMk id="25" creationId="{061E45F2-6FF8-42AE-90FF-6B5E0A17E7EF}"/>
          </ac:graphicFrameMkLst>
        </pc:graphicFrameChg>
        <pc:picChg chg="add mod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6" creationId="{891E1EEB-352A-4578-9C44-9818095A4DFC}"/>
          </ac:picMkLst>
        </pc:picChg>
        <pc:picChg chg="add mod">
          <ac:chgData name="Laurent Thomas" userId="d07c2afa-7600-4104-9c40-efdb3c9bb3fe" providerId="ADAL" clId="{490A42D8-2BFE-4E61-8267-051B5D9CC847}" dt="2019-07-03T12:28:59.703" v="668" actId="14826"/>
          <ac:picMkLst>
            <pc:docMk/>
            <pc:sldMk cId="607201000" sldId="265"/>
            <ac:picMk id="10" creationId="{F7AE4669-03A6-42E6-8D00-5A87670308E2}"/>
          </ac:picMkLst>
        </pc:picChg>
        <pc:picChg chg="mod topLvl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13" creationId="{51B33E0A-92B5-4F16-8FB0-DBC0FD5079E1}"/>
          </ac:picMkLst>
        </pc:picChg>
        <pc:picChg chg="del">
          <ac:chgData name="Laurent Thomas" userId="d07c2afa-7600-4104-9c40-efdb3c9bb3fe" providerId="ADAL" clId="{490A42D8-2BFE-4E61-8267-051B5D9CC847}" dt="2019-06-18T11:48:06.835" v="155" actId="478"/>
          <ac:picMkLst>
            <pc:docMk/>
            <pc:sldMk cId="607201000" sldId="265"/>
            <ac:picMk id="18" creationId="{A433050D-5009-486D-AF69-CD9DF47B7433}"/>
          </ac:picMkLst>
        </pc:picChg>
      </pc:sldChg>
    </pc:docChg>
  </pc:docChgLst>
  <pc:docChgLst>
    <pc:chgData name="Laurent Thomas" userId="d07c2afa-7600-4104-9c40-efdb3c9bb3fe" providerId="ADAL" clId="{F92ED90D-A762-4E30-88E9-B7C94278E4C2}"/>
  </pc:docChgLst>
  <pc:docChgLst>
    <pc:chgData name="Laurent Thomas" userId="d07c2afa-7600-4104-9c40-efdb3c9bb3fe" providerId="ADAL" clId="{A657B19A-A014-45F1-8401-7DAB6723BD43}"/>
  </pc:docChgLst>
  <pc:docChgLst>
    <pc:chgData name="Laurent Thomas" userId="d07c2afa-7600-4104-9c40-efdb3c9bb3fe" providerId="ADAL" clId="{61F582E7-660C-49A0-8E44-C025406C8306}"/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373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r">
              <a:defRPr sz="1300"/>
            </a:lvl1pPr>
          </a:lstStyle>
          <a:p>
            <a:fld id="{4EE9C0AC-1073-459E-8526-A4BB9542AE34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8" tIns="47779" rIns="95558" bIns="47779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5558" tIns="47779" rIns="95558" bIns="477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373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r">
              <a:defRPr sz="1300"/>
            </a:lvl1pPr>
          </a:lstStyle>
          <a:p>
            <a:fld id="{5652AAB4-1974-46A8-81BC-0DF4EE89AC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248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2AAB4-1974-46A8-81BC-0DF4EE89ACA9}" type="slidenum">
              <a:rPr lang="de-DE" smtClean="0"/>
              <a:pPr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8345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786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26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865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01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54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783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39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313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21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992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1" name="Group 120">
            <a:extLst>
              <a:ext uri="{FF2B5EF4-FFF2-40B4-BE49-F238E27FC236}">
                <a16:creationId xmlns:a16="http://schemas.microsoft.com/office/drawing/2014/main" id="{84FCB3E0-F128-4A93-BBE9-4EF0B6F007D5}"/>
              </a:ext>
            </a:extLst>
          </p:cNvPr>
          <p:cNvGrpSpPr/>
          <p:nvPr/>
        </p:nvGrpSpPr>
        <p:grpSpPr>
          <a:xfrm>
            <a:off x="1963579" y="316787"/>
            <a:ext cx="1735585" cy="1651827"/>
            <a:chOff x="921382" y="275388"/>
            <a:chExt cx="1735585" cy="1651827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E6E90D7-9171-4728-822A-1D353B4A3C67}"/>
                </a:ext>
              </a:extLst>
            </p:cNvPr>
            <p:cNvSpPr txBox="1"/>
            <p:nvPr/>
          </p:nvSpPr>
          <p:spPr>
            <a:xfrm>
              <a:off x="1306606" y="275388"/>
              <a:ext cx="973068" cy="461665"/>
            </a:xfrm>
            <a:prstGeom prst="flowChartInputOutpu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00B050"/>
                  </a:solidFill>
                </a:rPr>
                <a:t>INPUT</a:t>
              </a:r>
            </a:p>
            <a:p>
              <a:pPr algn="ctr"/>
              <a:r>
                <a:rPr lang="en-GB" sz="1200" dirty="0"/>
                <a:t>Image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3B7761E0-CC23-4626-AAB2-785BF6885132}"/>
                </a:ext>
              </a:extLst>
            </p:cNvPr>
            <p:cNvCxnSpPr>
              <a:cxnSpLocks/>
              <a:stCxn id="38" idx="4"/>
              <a:endCxn id="40" idx="1"/>
            </p:cNvCxnSpPr>
            <p:nvPr/>
          </p:nvCxnSpPr>
          <p:spPr>
            <a:xfrm flipH="1">
              <a:off x="1789175" y="737053"/>
              <a:ext cx="3965" cy="3591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96917C4-9062-4830-AF5D-E9A7D9E9DED7}"/>
                </a:ext>
              </a:extLst>
            </p:cNvPr>
            <p:cNvSpPr txBox="1"/>
            <p:nvPr/>
          </p:nvSpPr>
          <p:spPr>
            <a:xfrm>
              <a:off x="921382" y="1096218"/>
              <a:ext cx="1735585" cy="830997"/>
            </a:xfrm>
            <a:prstGeom prst="flowChartInputOutpu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00B050"/>
                  </a:solidFill>
                </a:rPr>
                <a:t>INPUT</a:t>
              </a:r>
            </a:p>
            <a:p>
              <a:pPr algn="ctr"/>
              <a:r>
                <a:rPr lang="en-GB" sz="1200" dirty="0"/>
                <a:t>rectangular </a:t>
              </a:r>
            </a:p>
            <a:p>
              <a:pPr algn="ctr"/>
              <a:r>
                <a:rPr lang="en-GB" sz="1200" dirty="0"/>
                <a:t>search region </a:t>
              </a:r>
            </a:p>
            <a:p>
              <a:pPr algn="ctr"/>
              <a:r>
                <a:rPr lang="en-GB" sz="1200" dirty="0"/>
                <a:t>(optional)</a:t>
              </a:r>
              <a:endParaRPr lang="de-DE" sz="1200" dirty="0"/>
            </a:p>
          </p:txBody>
        </p:sp>
      </p:grp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09513042-D2ED-4342-872C-5A540947E583}"/>
              </a:ext>
            </a:extLst>
          </p:cNvPr>
          <p:cNvCxnSpPr>
            <a:cxnSpLocks/>
            <a:stCxn id="40" idx="4"/>
            <a:endCxn id="56" idx="0"/>
          </p:cNvCxnSpPr>
          <p:nvPr/>
        </p:nvCxnSpPr>
        <p:spPr>
          <a:xfrm>
            <a:off x="2831372" y="1968614"/>
            <a:ext cx="0" cy="3926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830B5D57-56E3-49E1-A998-9693EF37E136}"/>
              </a:ext>
            </a:extLst>
          </p:cNvPr>
          <p:cNvGrpSpPr/>
          <p:nvPr/>
        </p:nvGrpSpPr>
        <p:grpSpPr>
          <a:xfrm>
            <a:off x="3681146" y="4059166"/>
            <a:ext cx="1404012" cy="1669084"/>
            <a:chOff x="2606142" y="3397543"/>
            <a:chExt cx="1404012" cy="1669084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9D4A27F-5F98-4969-9970-03E064212442}"/>
                </a:ext>
              </a:extLst>
            </p:cNvPr>
            <p:cNvSpPr txBox="1"/>
            <p:nvPr/>
          </p:nvSpPr>
          <p:spPr>
            <a:xfrm>
              <a:off x="2606142" y="3397543"/>
              <a:ext cx="1404012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Find local maxima</a:t>
              </a:r>
            </a:p>
          </p:txBody>
        </p: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C3E9952F-2F1C-48B2-B977-23D25B98C60F}"/>
                </a:ext>
              </a:extLst>
            </p:cNvPr>
            <p:cNvCxnSpPr>
              <a:cxnSpLocks/>
              <a:stCxn id="44" idx="2"/>
              <a:endCxn id="46" idx="0"/>
            </p:cNvCxnSpPr>
            <p:nvPr/>
          </p:nvCxnSpPr>
          <p:spPr>
            <a:xfrm>
              <a:off x="3308148" y="3674542"/>
              <a:ext cx="0" cy="74575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4F71D48-2AF5-4AD2-B062-E008ACDCD815}"/>
                </a:ext>
              </a:extLst>
            </p:cNvPr>
            <p:cNvSpPr txBox="1"/>
            <p:nvPr/>
          </p:nvSpPr>
          <p:spPr>
            <a:xfrm>
              <a:off x="2787198" y="4420296"/>
              <a:ext cx="1041899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Non-Maxima </a:t>
              </a:r>
            </a:p>
            <a:p>
              <a:pPr algn="ctr"/>
              <a:r>
                <a:rPr lang="en-GB" sz="1200" dirty="0"/>
                <a:t>Suppression (NMS)</a:t>
              </a:r>
              <a:endParaRPr lang="de-DE" sz="1200" dirty="0"/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D0E96AFC-E7AB-4F3F-A150-531C0B408BC4}"/>
              </a:ext>
            </a:extLst>
          </p:cNvPr>
          <p:cNvGrpSpPr/>
          <p:nvPr/>
        </p:nvGrpSpPr>
        <p:grpSpPr>
          <a:xfrm>
            <a:off x="407865" y="4065775"/>
            <a:ext cx="1630662" cy="1477809"/>
            <a:chOff x="1664597" y="5667277"/>
            <a:chExt cx="1630662" cy="1477809"/>
          </a:xfrm>
        </p:grpSpPr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4EAB6C41-984A-40B0-8C73-4A9A1A108819}"/>
                </a:ext>
              </a:extLst>
            </p:cNvPr>
            <p:cNvCxnSpPr>
              <a:cxnSpLocks/>
              <a:stCxn id="49" idx="2"/>
              <a:endCxn id="51" idx="0"/>
            </p:cNvCxnSpPr>
            <p:nvPr/>
          </p:nvCxnSpPr>
          <p:spPr>
            <a:xfrm>
              <a:off x="2479928" y="6128942"/>
              <a:ext cx="5759" cy="55447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EAA1AAB7-97E2-4444-ABEE-DBFEF0224EA2}"/>
                </a:ext>
              </a:extLst>
            </p:cNvPr>
            <p:cNvSpPr txBox="1"/>
            <p:nvPr/>
          </p:nvSpPr>
          <p:spPr>
            <a:xfrm>
              <a:off x="1664597" y="5667277"/>
              <a:ext cx="1630662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Find global maxima</a:t>
              </a:r>
            </a:p>
            <a:p>
              <a:pPr algn="ctr"/>
              <a:r>
                <a:rPr lang="en-GB" sz="1200" dirty="0"/>
                <a:t>(1 per map)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875FF30-57AF-40B6-8A2A-70F5098D2F29}"/>
                </a:ext>
              </a:extLst>
            </p:cNvPr>
            <p:cNvSpPr txBox="1"/>
            <p:nvPr/>
          </p:nvSpPr>
          <p:spPr>
            <a:xfrm>
              <a:off x="1808281" y="6683421"/>
              <a:ext cx="1354811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algn="ctr">
                <a:defRPr sz="1200"/>
              </a:lvl1pPr>
            </a:lstStyle>
            <a:p>
              <a:r>
                <a:rPr lang="en-GB" dirty="0"/>
                <a:t>Return the </a:t>
              </a:r>
            </a:p>
            <a:p>
              <a:r>
                <a:rPr lang="en-GB" dirty="0"/>
                <a:t>highest maximum</a:t>
              </a:r>
              <a:endParaRPr lang="de-DE" dirty="0"/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8628DE23-2D50-434D-885D-837C730F63D2}"/>
              </a:ext>
            </a:extLst>
          </p:cNvPr>
          <p:cNvGrpSpPr/>
          <p:nvPr/>
        </p:nvGrpSpPr>
        <p:grpSpPr>
          <a:xfrm>
            <a:off x="72976" y="316289"/>
            <a:ext cx="3729976" cy="2321993"/>
            <a:chOff x="-969825" y="1912134"/>
            <a:chExt cx="3729976" cy="2321993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4248011-6D31-4A8E-942D-A7618C0CDBBF}"/>
                </a:ext>
              </a:extLst>
            </p:cNvPr>
            <p:cNvSpPr txBox="1"/>
            <p:nvPr/>
          </p:nvSpPr>
          <p:spPr>
            <a:xfrm>
              <a:off x="-969825" y="1912134"/>
              <a:ext cx="1516626" cy="461665"/>
            </a:xfrm>
            <a:prstGeom prst="flowChartInputOutpu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00B050"/>
                  </a:solidFill>
                </a:rPr>
                <a:t>INPUT</a:t>
              </a:r>
            </a:p>
            <a:p>
              <a:pPr algn="ctr"/>
              <a:r>
                <a:rPr lang="en-GB" sz="1200" dirty="0"/>
                <a:t>Template(s)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FB5E110-3EE6-47E5-86AB-6EFEF7E6FCEC}"/>
                </a:ext>
              </a:extLst>
            </p:cNvPr>
            <p:cNvSpPr txBox="1"/>
            <p:nvPr/>
          </p:nvSpPr>
          <p:spPr>
            <a:xfrm>
              <a:off x="816990" y="3957128"/>
              <a:ext cx="1943161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/>
                <a:t>Compute correlation map(s)</a:t>
              </a:r>
              <a:endParaRPr lang="de-DE" sz="1200" dirty="0"/>
            </a:p>
          </p:txBody>
        </p:sp>
        <p:cxnSp>
          <p:nvCxnSpPr>
            <p:cNvPr id="95" name="Connector: Elbow 94">
              <a:extLst>
                <a:ext uri="{FF2B5EF4-FFF2-40B4-BE49-F238E27FC236}">
                  <a16:creationId xmlns:a16="http://schemas.microsoft.com/office/drawing/2014/main" id="{06855F62-3EAE-4881-B188-3BC1B6B88948}"/>
                </a:ext>
              </a:extLst>
            </p:cNvPr>
            <p:cNvCxnSpPr>
              <a:cxnSpLocks/>
              <a:stCxn id="96" idx="2"/>
              <a:endCxn id="56" idx="1"/>
            </p:cNvCxnSpPr>
            <p:nvPr/>
          </p:nvCxnSpPr>
          <p:spPr>
            <a:xfrm rot="16200000" flipH="1">
              <a:off x="-39930" y="3238707"/>
              <a:ext cx="685339" cy="1028502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8A79011D-45F8-4D18-AAA5-823BA213A4A1}"/>
              </a:ext>
            </a:extLst>
          </p:cNvPr>
          <p:cNvGrpSpPr/>
          <p:nvPr/>
        </p:nvGrpSpPr>
        <p:grpSpPr>
          <a:xfrm>
            <a:off x="1228955" y="5543584"/>
            <a:ext cx="3154197" cy="2001133"/>
            <a:chOff x="7715" y="4121778"/>
            <a:chExt cx="3154197" cy="2001133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4088D06-A464-4F33-BAE2-4E317B1EC906}"/>
                </a:ext>
              </a:extLst>
            </p:cNvPr>
            <p:cNvSpPr txBox="1"/>
            <p:nvPr/>
          </p:nvSpPr>
          <p:spPr>
            <a:xfrm>
              <a:off x="472169" y="5291914"/>
              <a:ext cx="2184510" cy="830997"/>
            </a:xfrm>
            <a:prstGeom prst="flowChartInputOutpu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>
                <a:defRPr sz="1200"/>
              </a:lvl1pPr>
            </a:lstStyle>
            <a:p>
              <a:pPr algn="ctr"/>
              <a:r>
                <a:rPr lang="en-GB" b="1" dirty="0">
                  <a:solidFill>
                    <a:srgbClr val="FF0000"/>
                  </a:solidFill>
                </a:rPr>
                <a:t>OUTPUT</a:t>
              </a:r>
            </a:p>
            <a:p>
              <a:pPr algn="ctr"/>
              <a:r>
                <a:rPr lang="en-GB" dirty="0"/>
                <a:t>Return bounding box(es)</a:t>
              </a:r>
            </a:p>
            <a:p>
              <a:pPr algn="ctr"/>
              <a:r>
                <a:rPr lang="en-GB" dirty="0"/>
                <a:t> and score(s)</a:t>
              </a:r>
              <a:endParaRPr lang="de-DE" dirty="0"/>
            </a:p>
          </p:txBody>
        </p:sp>
        <p:cxnSp>
          <p:nvCxnSpPr>
            <p:cNvPr id="123" name="Straight Arrow Connector 122">
              <a:extLst>
                <a:ext uri="{FF2B5EF4-FFF2-40B4-BE49-F238E27FC236}">
                  <a16:creationId xmlns:a16="http://schemas.microsoft.com/office/drawing/2014/main" id="{FCC0786E-DDC6-4145-A1D4-33C4B98D3D60}"/>
                </a:ext>
              </a:extLst>
            </p:cNvPr>
            <p:cNvCxnSpPr>
              <a:cxnSpLocks/>
              <a:stCxn id="51" idx="2"/>
              <a:endCxn id="48" idx="1"/>
            </p:cNvCxnSpPr>
            <p:nvPr/>
          </p:nvCxnSpPr>
          <p:spPr>
            <a:xfrm>
              <a:off x="7715" y="4121778"/>
              <a:ext cx="1556709" cy="11701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463C9B58-0BD6-4188-B431-34C7FE1BFC85}"/>
                </a:ext>
              </a:extLst>
            </p:cNvPr>
            <p:cNvCxnSpPr>
              <a:cxnSpLocks/>
              <a:stCxn id="46" idx="2"/>
              <a:endCxn id="48" idx="0"/>
            </p:cNvCxnSpPr>
            <p:nvPr/>
          </p:nvCxnSpPr>
          <p:spPr>
            <a:xfrm flipH="1">
              <a:off x="1782875" y="4306444"/>
              <a:ext cx="1379037" cy="98547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Flowchart: Decision 1">
            <a:extLst>
              <a:ext uri="{FF2B5EF4-FFF2-40B4-BE49-F238E27FC236}">
                <a16:creationId xmlns:a16="http://schemas.microsoft.com/office/drawing/2014/main" id="{5E5F3B38-E01A-4937-A891-2936F2F20719}"/>
              </a:ext>
            </a:extLst>
          </p:cNvPr>
          <p:cNvSpPr/>
          <p:nvPr/>
        </p:nvSpPr>
        <p:spPr>
          <a:xfrm>
            <a:off x="1847885" y="3032717"/>
            <a:ext cx="1965351" cy="550247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sz="1200" dirty="0" err="1"/>
              <a:t>N_object</a:t>
            </a:r>
            <a:r>
              <a:rPr lang="en-GB" sz="1200" dirty="0"/>
              <a:t> </a:t>
            </a:r>
            <a:r>
              <a:rPr lang="en-GB" sz="1200"/>
              <a:t>&gt; 1</a:t>
            </a:r>
            <a:endParaRPr lang="de-DE" sz="1200" dirty="0"/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90A78F14-09EC-44EE-934C-5BF39546C732}"/>
              </a:ext>
            </a:extLst>
          </p:cNvPr>
          <p:cNvCxnSpPr>
            <a:stCxn id="56" idx="2"/>
            <a:endCxn id="2" idx="0"/>
          </p:cNvCxnSpPr>
          <p:nvPr/>
        </p:nvCxnSpPr>
        <p:spPr>
          <a:xfrm flipH="1">
            <a:off x="2830561" y="2638282"/>
            <a:ext cx="811" cy="3944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or: Elbow 6">
            <a:extLst>
              <a:ext uri="{FF2B5EF4-FFF2-40B4-BE49-F238E27FC236}">
                <a16:creationId xmlns:a16="http://schemas.microsoft.com/office/drawing/2014/main" id="{2FFC3740-FDAC-4A74-823C-2FEFAEB9FBA7}"/>
              </a:ext>
            </a:extLst>
          </p:cNvPr>
          <p:cNvCxnSpPr>
            <a:cxnSpLocks/>
          </p:cNvCxnSpPr>
          <p:nvPr/>
        </p:nvCxnSpPr>
        <p:spPr>
          <a:xfrm rot="10800000" flipV="1">
            <a:off x="1223197" y="3303166"/>
            <a:ext cx="674044" cy="75600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3CC5C1F-653A-4A9C-A52F-F8AACF65B166}"/>
              </a:ext>
            </a:extLst>
          </p:cNvPr>
          <p:cNvSpPr txBox="1"/>
          <p:nvPr/>
        </p:nvSpPr>
        <p:spPr>
          <a:xfrm>
            <a:off x="1223196" y="2969128"/>
            <a:ext cx="556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False</a:t>
            </a:r>
            <a:endParaRPr lang="de-DE" sz="1200" dirty="0"/>
          </a:p>
        </p:txBody>
      </p:sp>
      <p:cxnSp>
        <p:nvCxnSpPr>
          <p:cNvPr id="61" name="Connector: Elbow 60">
            <a:extLst>
              <a:ext uri="{FF2B5EF4-FFF2-40B4-BE49-F238E27FC236}">
                <a16:creationId xmlns:a16="http://schemas.microsoft.com/office/drawing/2014/main" id="{738F433A-D384-4CB1-85F7-4059558C524B}"/>
              </a:ext>
            </a:extLst>
          </p:cNvPr>
          <p:cNvCxnSpPr>
            <a:cxnSpLocks/>
            <a:stCxn id="2" idx="3"/>
            <a:endCxn id="44" idx="0"/>
          </p:cNvCxnSpPr>
          <p:nvPr/>
        </p:nvCxnSpPr>
        <p:spPr>
          <a:xfrm>
            <a:off x="3813236" y="3307841"/>
            <a:ext cx="569916" cy="751325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7F09845E-0DCB-4914-8440-8100D671904D}"/>
              </a:ext>
            </a:extLst>
          </p:cNvPr>
          <p:cNvSpPr txBox="1"/>
          <p:nvPr/>
        </p:nvSpPr>
        <p:spPr>
          <a:xfrm>
            <a:off x="3831659" y="2969127"/>
            <a:ext cx="508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True</a:t>
            </a:r>
            <a:endParaRPr lang="de-DE" sz="1200" dirty="0"/>
          </a:p>
        </p:txBody>
      </p:sp>
      <p:sp>
        <p:nvSpPr>
          <p:cNvPr id="96" name="Flowchart: Process 95">
            <a:extLst>
              <a:ext uri="{FF2B5EF4-FFF2-40B4-BE49-F238E27FC236}">
                <a16:creationId xmlns:a16="http://schemas.microsoft.com/office/drawing/2014/main" id="{317835C3-EBF1-45E8-892B-816202E3E8AD}"/>
              </a:ext>
            </a:extLst>
          </p:cNvPr>
          <p:cNvSpPr/>
          <p:nvPr/>
        </p:nvSpPr>
        <p:spPr>
          <a:xfrm>
            <a:off x="167069" y="1218898"/>
            <a:ext cx="1328440" cy="595546"/>
          </a:xfrm>
          <a:prstGeom prst="flowChartProcess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otation/flipping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(optional)</a:t>
            </a:r>
            <a:endParaRPr lang="de-DE" sz="1200" dirty="0">
              <a:solidFill>
                <a:schemeClr val="tx1"/>
              </a:solidFill>
            </a:endParaRPr>
          </a:p>
        </p:txBody>
      </p: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7D6D6FFB-09BE-484E-ACB2-B0C19C8FC12C}"/>
              </a:ext>
            </a:extLst>
          </p:cNvPr>
          <p:cNvCxnSpPr>
            <a:cxnSpLocks/>
            <a:stCxn id="57" idx="4"/>
            <a:endCxn id="96" idx="0"/>
          </p:cNvCxnSpPr>
          <p:nvPr/>
        </p:nvCxnSpPr>
        <p:spPr>
          <a:xfrm>
            <a:off x="831289" y="777954"/>
            <a:ext cx="0" cy="4409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10656CBB-C11C-4DEC-9278-9B23BE0B751C}"/>
              </a:ext>
            </a:extLst>
          </p:cNvPr>
          <p:cNvSpPr txBox="1"/>
          <p:nvPr/>
        </p:nvSpPr>
        <p:spPr>
          <a:xfrm>
            <a:off x="4633852" y="1137617"/>
            <a:ext cx="2155901" cy="830997"/>
          </a:xfrm>
          <a:prstGeom prst="flowChartInputOutpu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B050"/>
                </a:solidFill>
              </a:rPr>
              <a:t>INPUT</a:t>
            </a:r>
          </a:p>
          <a:p>
            <a:pPr algn="ctr"/>
            <a:r>
              <a:rPr lang="en-GB" sz="1200" dirty="0"/>
              <a:t>Expected number </a:t>
            </a:r>
          </a:p>
          <a:p>
            <a:pPr algn="ctr"/>
            <a:r>
              <a:rPr lang="en-GB" sz="1200" dirty="0"/>
              <a:t>of objects (</a:t>
            </a:r>
            <a:r>
              <a:rPr lang="en-GB" sz="1200" dirty="0" err="1"/>
              <a:t>N_object</a:t>
            </a:r>
            <a:r>
              <a:rPr lang="en-GB" sz="1200" dirty="0"/>
              <a:t>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DB22055-81AE-4F2C-97C1-BFE86E4C1644}"/>
              </a:ext>
            </a:extLst>
          </p:cNvPr>
          <p:cNvSpPr txBox="1"/>
          <p:nvPr/>
        </p:nvSpPr>
        <p:spPr>
          <a:xfrm>
            <a:off x="5323765" y="3874499"/>
            <a:ext cx="1404012" cy="646331"/>
          </a:xfrm>
          <a:prstGeom prst="flowChartInputOutpu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B050"/>
                </a:solidFill>
              </a:rPr>
              <a:t>INPUT</a:t>
            </a:r>
          </a:p>
          <a:p>
            <a:pPr algn="ctr"/>
            <a:r>
              <a:rPr lang="en-GB" sz="1200" dirty="0"/>
              <a:t>score-threshold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9B12622-BE5E-4247-8FEA-96583BD01910}"/>
              </a:ext>
            </a:extLst>
          </p:cNvPr>
          <p:cNvCxnSpPr>
            <a:stCxn id="62" idx="2"/>
            <a:endCxn id="44" idx="3"/>
          </p:cNvCxnSpPr>
          <p:nvPr/>
        </p:nvCxnSpPr>
        <p:spPr>
          <a:xfrm flipH="1">
            <a:off x="5085158" y="4197665"/>
            <a:ext cx="379008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or: Elbow 31">
            <a:extLst>
              <a:ext uri="{FF2B5EF4-FFF2-40B4-BE49-F238E27FC236}">
                <a16:creationId xmlns:a16="http://schemas.microsoft.com/office/drawing/2014/main" id="{98877C48-F156-457F-BE37-533A1FA79DA2}"/>
              </a:ext>
            </a:extLst>
          </p:cNvPr>
          <p:cNvCxnSpPr>
            <a:cxnSpLocks/>
            <a:stCxn id="43" idx="4"/>
          </p:cNvCxnSpPr>
          <p:nvPr/>
        </p:nvCxnSpPr>
        <p:spPr>
          <a:xfrm rot="5400000">
            <a:off x="3838529" y="960646"/>
            <a:ext cx="865307" cy="2881242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9459A3A2-5A54-49B4-8327-92F1579700C7}"/>
              </a:ext>
            </a:extLst>
          </p:cNvPr>
          <p:cNvSpPr txBox="1"/>
          <p:nvPr/>
        </p:nvSpPr>
        <p:spPr>
          <a:xfrm>
            <a:off x="5323765" y="5081919"/>
            <a:ext cx="1465988" cy="646331"/>
          </a:xfrm>
          <a:prstGeom prst="flowChartInputOutpu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B050"/>
                </a:solidFill>
              </a:rPr>
              <a:t>INPUT</a:t>
            </a:r>
          </a:p>
          <a:p>
            <a:pPr algn="ctr"/>
            <a:r>
              <a:rPr lang="en-GB" sz="1200" dirty="0" err="1"/>
              <a:t>IoU</a:t>
            </a:r>
            <a:r>
              <a:rPr lang="en-GB" sz="1200" dirty="0"/>
              <a:t> threshold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9A8A3637-874D-41C4-9DBC-5B1FF0E81DBC}"/>
              </a:ext>
            </a:extLst>
          </p:cNvPr>
          <p:cNvCxnSpPr>
            <a:cxnSpLocks/>
            <a:stCxn id="70" idx="2"/>
            <a:endCxn id="46" idx="3"/>
          </p:cNvCxnSpPr>
          <p:nvPr/>
        </p:nvCxnSpPr>
        <p:spPr>
          <a:xfrm flipH="1">
            <a:off x="4904101" y="5405085"/>
            <a:ext cx="56626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8917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2</Words>
  <Application>Microsoft Office PowerPoint</Application>
  <PresentationFormat>A4 Paper (210x297 mm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Thomas</dc:creator>
  <cp:lastModifiedBy>Laurent Thomas</cp:lastModifiedBy>
  <cp:revision>125</cp:revision>
  <cp:lastPrinted>2019-04-25T15:59:25Z</cp:lastPrinted>
  <dcterms:created xsi:type="dcterms:W3CDTF">2019-01-23T08:47:48Z</dcterms:created>
  <dcterms:modified xsi:type="dcterms:W3CDTF">2019-11-25T11:47:40Z</dcterms:modified>
</cp:coreProperties>
</file>